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5ADAD"/>
    <a:srgbClr val="738FA8"/>
    <a:srgbClr val="28557D"/>
    <a:srgbClr val="FE0303"/>
    <a:srgbClr val="F4C7C7"/>
    <a:srgbClr val="A0B3C5"/>
    <a:srgbClr val="819AB0"/>
    <a:srgbClr val="1F4E78"/>
    <a:srgbClr val="6685A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16" autoAdjust="0"/>
    <p:restoredTop sz="94660"/>
  </p:normalViewPr>
  <p:slideViewPr>
    <p:cSldViewPr snapToGrid="0">
      <p:cViewPr varScale="1">
        <p:scale>
          <a:sx n="58" d="100"/>
          <a:sy n="58" d="100"/>
        </p:scale>
        <p:origin x="264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A59-477F-BD54-EE1B13749BBA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A59-477F-BD54-EE1B13749BBA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A59-477F-BD54-EE1B13749BBA}"/>
              </c:ext>
            </c:extLst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A59-477F-BD54-EE1B13749BBA}"/>
              </c:ext>
            </c:extLst>
          </c:dPt>
          <c:dPt>
            <c:idx val="8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2A59-477F-BD54-EE1B13749BBA}"/>
              </c:ext>
            </c:extLst>
          </c:dPt>
          <c:dPt>
            <c:idx val="1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2A59-477F-BD54-EE1B13749BBA}"/>
              </c:ext>
            </c:extLst>
          </c:dPt>
          <c:dPt>
            <c:idx val="25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2A59-477F-BD54-EE1B13749BBA}"/>
              </c:ext>
            </c:extLst>
          </c:dPt>
          <c:dPt>
            <c:idx val="6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2A59-477F-BD54-EE1B13749BBA}"/>
              </c:ext>
            </c:extLst>
          </c:dPt>
          <c:dPt>
            <c:idx val="67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2A59-477F-BD54-EE1B13749BBA}"/>
              </c:ext>
            </c:extLst>
          </c:dPt>
          <c:dPt>
            <c:idx val="8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2A59-477F-BD54-EE1B13749BBA}"/>
              </c:ext>
            </c:extLst>
          </c:dPt>
          <c:dPt>
            <c:idx val="87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2A59-477F-BD54-EE1B13749BBA}"/>
              </c:ext>
            </c:extLst>
          </c:dPt>
          <c:cat>
            <c:strRef>
              <c:f>'S1_bioassay_99_isolates (2)'!$C$62:$CX$62</c:f>
              <c:strCache>
                <c:ptCount val="100"/>
                <c:pt idx="0">
                  <c:v>Non-treated control</c:v>
                </c:pt>
                <c:pt idx="1">
                  <c:v>JEF-405</c:v>
                </c:pt>
                <c:pt idx="2">
                  <c:v>JEF-406</c:v>
                </c:pt>
                <c:pt idx="3">
                  <c:v>JEF-407</c:v>
                </c:pt>
                <c:pt idx="4">
                  <c:v>JEF-408</c:v>
                </c:pt>
                <c:pt idx="5">
                  <c:v>JEF-410</c:v>
                </c:pt>
                <c:pt idx="6">
                  <c:v>JEF-411</c:v>
                </c:pt>
                <c:pt idx="7">
                  <c:v>JEF-414</c:v>
                </c:pt>
                <c:pt idx="8">
                  <c:v>JEF-415</c:v>
                </c:pt>
                <c:pt idx="9">
                  <c:v>JEF-417</c:v>
                </c:pt>
                <c:pt idx="10">
                  <c:v>JEF-419</c:v>
                </c:pt>
                <c:pt idx="11">
                  <c:v>JEF-420</c:v>
                </c:pt>
                <c:pt idx="12">
                  <c:v>JEF-422</c:v>
                </c:pt>
                <c:pt idx="13">
                  <c:v>JEF-423</c:v>
                </c:pt>
                <c:pt idx="14">
                  <c:v>JEF-424</c:v>
                </c:pt>
                <c:pt idx="15">
                  <c:v>JEF-427</c:v>
                </c:pt>
                <c:pt idx="16">
                  <c:v>JEF-428</c:v>
                </c:pt>
                <c:pt idx="17">
                  <c:v>JEF-158</c:v>
                </c:pt>
                <c:pt idx="18">
                  <c:v>JEF-162</c:v>
                </c:pt>
                <c:pt idx="19">
                  <c:v>JEF-164</c:v>
                </c:pt>
                <c:pt idx="20">
                  <c:v>JEF-165</c:v>
                </c:pt>
                <c:pt idx="21">
                  <c:v>JEF-167</c:v>
                </c:pt>
                <c:pt idx="22">
                  <c:v>JEF-168</c:v>
                </c:pt>
                <c:pt idx="23">
                  <c:v>JEF-169</c:v>
                </c:pt>
                <c:pt idx="24">
                  <c:v>JEF-226</c:v>
                </c:pt>
                <c:pt idx="25">
                  <c:v>JEF-232</c:v>
                </c:pt>
                <c:pt idx="26">
                  <c:v>JEF-326</c:v>
                </c:pt>
                <c:pt idx="27">
                  <c:v>JEF-327</c:v>
                </c:pt>
                <c:pt idx="28">
                  <c:v>JEF-331</c:v>
                </c:pt>
                <c:pt idx="29">
                  <c:v>JEF-378</c:v>
                </c:pt>
                <c:pt idx="30">
                  <c:v>JEF-379</c:v>
                </c:pt>
                <c:pt idx="31">
                  <c:v>JEF-381</c:v>
                </c:pt>
                <c:pt idx="32">
                  <c:v>JEF-385</c:v>
                </c:pt>
                <c:pt idx="33">
                  <c:v>JEF-388</c:v>
                </c:pt>
                <c:pt idx="34">
                  <c:v>JEF-392</c:v>
                </c:pt>
                <c:pt idx="35">
                  <c:v>JEF-441</c:v>
                </c:pt>
                <c:pt idx="36">
                  <c:v>JEF-442</c:v>
                </c:pt>
                <c:pt idx="37">
                  <c:v>JEF-443</c:v>
                </c:pt>
                <c:pt idx="38">
                  <c:v>JEF-451</c:v>
                </c:pt>
                <c:pt idx="39">
                  <c:v>JEF-472</c:v>
                </c:pt>
                <c:pt idx="40">
                  <c:v>JEF-475</c:v>
                </c:pt>
                <c:pt idx="41">
                  <c:v>JEF-477</c:v>
                </c:pt>
                <c:pt idx="42">
                  <c:v>JEF-478</c:v>
                </c:pt>
                <c:pt idx="43">
                  <c:v>JEF-480</c:v>
                </c:pt>
                <c:pt idx="44">
                  <c:v>JEF-481</c:v>
                </c:pt>
                <c:pt idx="45">
                  <c:v>JEF-482</c:v>
                </c:pt>
                <c:pt idx="46">
                  <c:v>JEF-483</c:v>
                </c:pt>
                <c:pt idx="47">
                  <c:v>JEF-484</c:v>
                </c:pt>
                <c:pt idx="48">
                  <c:v>JEF-485</c:v>
                </c:pt>
                <c:pt idx="49">
                  <c:v>JEF-496</c:v>
                </c:pt>
                <c:pt idx="50">
                  <c:v>JEF-497</c:v>
                </c:pt>
                <c:pt idx="51">
                  <c:v>JEF-498</c:v>
                </c:pt>
                <c:pt idx="52">
                  <c:v>JEF-499</c:v>
                </c:pt>
                <c:pt idx="53">
                  <c:v>JEF-500</c:v>
                </c:pt>
                <c:pt idx="54">
                  <c:v>JEF-501</c:v>
                </c:pt>
                <c:pt idx="55">
                  <c:v>JEF-502</c:v>
                </c:pt>
                <c:pt idx="56">
                  <c:v>JEF-503</c:v>
                </c:pt>
                <c:pt idx="57">
                  <c:v>JEF-505</c:v>
                </c:pt>
                <c:pt idx="58">
                  <c:v>JEF-507</c:v>
                </c:pt>
                <c:pt idx="59">
                  <c:v>JEF-509</c:v>
                </c:pt>
                <c:pt idx="60">
                  <c:v>JEF-510</c:v>
                </c:pt>
                <c:pt idx="61">
                  <c:v>JEF-511</c:v>
                </c:pt>
                <c:pt idx="62">
                  <c:v>JEF-512</c:v>
                </c:pt>
                <c:pt idx="63">
                  <c:v>JEF-514</c:v>
                </c:pt>
                <c:pt idx="64">
                  <c:v>JEF-515</c:v>
                </c:pt>
                <c:pt idx="65">
                  <c:v>JEF-516</c:v>
                </c:pt>
                <c:pt idx="66">
                  <c:v>JEF-517</c:v>
                </c:pt>
                <c:pt idx="67">
                  <c:v>JEF-519</c:v>
                </c:pt>
                <c:pt idx="68">
                  <c:v>JEF-520</c:v>
                </c:pt>
                <c:pt idx="69">
                  <c:v>JEF-521</c:v>
                </c:pt>
                <c:pt idx="70">
                  <c:v>JEF-522</c:v>
                </c:pt>
                <c:pt idx="71">
                  <c:v>JEF-523</c:v>
                </c:pt>
                <c:pt idx="72">
                  <c:v>JEF-525</c:v>
                </c:pt>
                <c:pt idx="73">
                  <c:v>JEF-526</c:v>
                </c:pt>
                <c:pt idx="74">
                  <c:v>JEF-528</c:v>
                </c:pt>
                <c:pt idx="75">
                  <c:v>JEF-529</c:v>
                </c:pt>
                <c:pt idx="76">
                  <c:v>JEF-530</c:v>
                </c:pt>
                <c:pt idx="77">
                  <c:v>JEF-531</c:v>
                </c:pt>
                <c:pt idx="78">
                  <c:v>JEF-534</c:v>
                </c:pt>
                <c:pt idx="79">
                  <c:v>JEF-535</c:v>
                </c:pt>
                <c:pt idx="80">
                  <c:v>JEF-536</c:v>
                </c:pt>
                <c:pt idx="81">
                  <c:v>JEF-537</c:v>
                </c:pt>
                <c:pt idx="82">
                  <c:v>JEF-538</c:v>
                </c:pt>
                <c:pt idx="83">
                  <c:v>JEF-540</c:v>
                </c:pt>
                <c:pt idx="84">
                  <c:v>JEF-541</c:v>
                </c:pt>
                <c:pt idx="85">
                  <c:v>JEF-542</c:v>
                </c:pt>
                <c:pt idx="86">
                  <c:v>JEF-544</c:v>
                </c:pt>
                <c:pt idx="87">
                  <c:v>JEF-545</c:v>
                </c:pt>
                <c:pt idx="88">
                  <c:v>JEF-546</c:v>
                </c:pt>
                <c:pt idx="89">
                  <c:v>JEF-551</c:v>
                </c:pt>
                <c:pt idx="90">
                  <c:v>JEF-552</c:v>
                </c:pt>
                <c:pt idx="91">
                  <c:v>JEF-555</c:v>
                </c:pt>
                <c:pt idx="92">
                  <c:v>JEF-556</c:v>
                </c:pt>
                <c:pt idx="93">
                  <c:v>JEF-557</c:v>
                </c:pt>
                <c:pt idx="94">
                  <c:v>JEF-558</c:v>
                </c:pt>
                <c:pt idx="95">
                  <c:v>JEF-559</c:v>
                </c:pt>
                <c:pt idx="96">
                  <c:v>JEF-560</c:v>
                </c:pt>
                <c:pt idx="97">
                  <c:v>JEF-563</c:v>
                </c:pt>
                <c:pt idx="98">
                  <c:v>JEF-565</c:v>
                </c:pt>
                <c:pt idx="99">
                  <c:v>JEF-566</c:v>
                </c:pt>
              </c:strCache>
            </c:strRef>
          </c:cat>
          <c:val>
            <c:numRef>
              <c:f>'S1_bioassay_99_isolates (2)'!$C$63:$CX$63</c:f>
              <c:numCache>
                <c:formatCode>General</c:formatCode>
                <c:ptCount val="100"/>
                <c:pt idx="0">
                  <c:v>20</c:v>
                </c:pt>
                <c:pt idx="1">
                  <c:v>100</c:v>
                </c:pt>
                <c:pt idx="2">
                  <c:v>86.206896551724142</c:v>
                </c:pt>
                <c:pt idx="3">
                  <c:v>50.943396226415096</c:v>
                </c:pt>
                <c:pt idx="4">
                  <c:v>87.5</c:v>
                </c:pt>
                <c:pt idx="5">
                  <c:v>56.164383561643838</c:v>
                </c:pt>
                <c:pt idx="6">
                  <c:v>75</c:v>
                </c:pt>
                <c:pt idx="7">
                  <c:v>97.297297297297291</c:v>
                </c:pt>
                <c:pt idx="8">
                  <c:v>95.652173913043484</c:v>
                </c:pt>
                <c:pt idx="9">
                  <c:v>76.666666666666671</c:v>
                </c:pt>
                <c:pt idx="10">
                  <c:v>93.75</c:v>
                </c:pt>
                <c:pt idx="11">
                  <c:v>65.78947368421052</c:v>
                </c:pt>
                <c:pt idx="12">
                  <c:v>36.363636363636367</c:v>
                </c:pt>
                <c:pt idx="13">
                  <c:v>66.101694915254242</c:v>
                </c:pt>
                <c:pt idx="14">
                  <c:v>76.666666666666671</c:v>
                </c:pt>
                <c:pt idx="15">
                  <c:v>67.948717948717956</c:v>
                </c:pt>
                <c:pt idx="16">
                  <c:v>82.222222222222229</c:v>
                </c:pt>
                <c:pt idx="17">
                  <c:v>16.21621621621621</c:v>
                </c:pt>
                <c:pt idx="18">
                  <c:v>-13.63636363636364</c:v>
                </c:pt>
                <c:pt idx="19">
                  <c:v>84.415584415584419</c:v>
                </c:pt>
                <c:pt idx="20">
                  <c:v>23.703703703703709</c:v>
                </c:pt>
                <c:pt idx="21">
                  <c:v>17.391304347826093</c:v>
                </c:pt>
                <c:pt idx="22">
                  <c:v>48.936170212765958</c:v>
                </c:pt>
                <c:pt idx="23">
                  <c:v>-74.418604651162781</c:v>
                </c:pt>
                <c:pt idx="24">
                  <c:v>-45.454545454545467</c:v>
                </c:pt>
                <c:pt idx="25">
                  <c:v>100</c:v>
                </c:pt>
                <c:pt idx="26">
                  <c:v>23.076923076923066</c:v>
                </c:pt>
                <c:pt idx="27">
                  <c:v>-56</c:v>
                </c:pt>
                <c:pt idx="28">
                  <c:v>38.888888888888886</c:v>
                </c:pt>
                <c:pt idx="29">
                  <c:v>30.075187969924812</c:v>
                </c:pt>
                <c:pt idx="30">
                  <c:v>-3.448275862068968</c:v>
                </c:pt>
                <c:pt idx="31">
                  <c:v>1.1235955056179847</c:v>
                </c:pt>
                <c:pt idx="32">
                  <c:v>33.333333333333343</c:v>
                </c:pt>
                <c:pt idx="33">
                  <c:v>4.2253521126760631</c:v>
                </c:pt>
                <c:pt idx="34">
                  <c:v>-66.037735849056617</c:v>
                </c:pt>
                <c:pt idx="35">
                  <c:v>0</c:v>
                </c:pt>
                <c:pt idx="36">
                  <c:v>-12.658227848101262</c:v>
                </c:pt>
                <c:pt idx="37">
                  <c:v>60.439560439560438</c:v>
                </c:pt>
                <c:pt idx="38">
                  <c:v>-82.5</c:v>
                </c:pt>
                <c:pt idx="39">
                  <c:v>-39.393939393939405</c:v>
                </c:pt>
                <c:pt idx="40">
                  <c:v>17.64705882352942</c:v>
                </c:pt>
                <c:pt idx="41">
                  <c:v>60.416666666666671</c:v>
                </c:pt>
                <c:pt idx="42">
                  <c:v>54.545454545454547</c:v>
                </c:pt>
                <c:pt idx="43">
                  <c:v>-294.11764705882354</c:v>
                </c:pt>
                <c:pt idx="44">
                  <c:v>-27.397260273972606</c:v>
                </c:pt>
                <c:pt idx="45">
                  <c:v>-65.78947368421052</c:v>
                </c:pt>
                <c:pt idx="46">
                  <c:v>55.555555555555557</c:v>
                </c:pt>
                <c:pt idx="47">
                  <c:v>38.157894736842103</c:v>
                </c:pt>
                <c:pt idx="48">
                  <c:v>53.75722543352601</c:v>
                </c:pt>
                <c:pt idx="49">
                  <c:v>-359.99999999999994</c:v>
                </c:pt>
                <c:pt idx="50">
                  <c:v>39.032258064516135</c:v>
                </c:pt>
                <c:pt idx="51">
                  <c:v>28</c:v>
                </c:pt>
                <c:pt idx="52">
                  <c:v>28.571428571428569</c:v>
                </c:pt>
                <c:pt idx="53">
                  <c:v>35</c:v>
                </c:pt>
                <c:pt idx="54">
                  <c:v>46.153846153846153</c:v>
                </c:pt>
                <c:pt idx="55">
                  <c:v>25.5</c:v>
                </c:pt>
                <c:pt idx="56">
                  <c:v>-322.49999999999994</c:v>
                </c:pt>
                <c:pt idx="57">
                  <c:v>30</c:v>
                </c:pt>
                <c:pt idx="58">
                  <c:v>11.666666666666671</c:v>
                </c:pt>
                <c:pt idx="59">
                  <c:v>12.272727272727266</c:v>
                </c:pt>
                <c:pt idx="60">
                  <c:v>29.285714285714278</c:v>
                </c:pt>
                <c:pt idx="61">
                  <c:v>-44.285714285714278</c:v>
                </c:pt>
                <c:pt idx="62">
                  <c:v>-154.99999999999997</c:v>
                </c:pt>
                <c:pt idx="63">
                  <c:v>36.666666666666671</c:v>
                </c:pt>
                <c:pt idx="64">
                  <c:v>13.07692307692308</c:v>
                </c:pt>
                <c:pt idx="65">
                  <c:v>24.285714285714292</c:v>
                </c:pt>
                <c:pt idx="66">
                  <c:v>100</c:v>
                </c:pt>
                <c:pt idx="67">
                  <c:v>90</c:v>
                </c:pt>
                <c:pt idx="68">
                  <c:v>25.666666666666671</c:v>
                </c:pt>
                <c:pt idx="69">
                  <c:v>48.333333333333329</c:v>
                </c:pt>
                <c:pt idx="70">
                  <c:v>25</c:v>
                </c:pt>
                <c:pt idx="71">
                  <c:v>61.515151515151516</c:v>
                </c:pt>
                <c:pt idx="72">
                  <c:v>53.571428571428569</c:v>
                </c:pt>
                <c:pt idx="73">
                  <c:v>27.083333333333343</c:v>
                </c:pt>
                <c:pt idx="74">
                  <c:v>25</c:v>
                </c:pt>
                <c:pt idx="75">
                  <c:v>17.5</c:v>
                </c:pt>
                <c:pt idx="76">
                  <c:v>20</c:v>
                </c:pt>
                <c:pt idx="77">
                  <c:v>35.714285714285708</c:v>
                </c:pt>
                <c:pt idx="78">
                  <c:v>31.333333333333329</c:v>
                </c:pt>
                <c:pt idx="79">
                  <c:v>30.434782608695656</c:v>
                </c:pt>
                <c:pt idx="80">
                  <c:v>24.642857142857139</c:v>
                </c:pt>
                <c:pt idx="81">
                  <c:v>41.304347826086953</c:v>
                </c:pt>
                <c:pt idx="82">
                  <c:v>32.38095238095238</c:v>
                </c:pt>
                <c:pt idx="83">
                  <c:v>40</c:v>
                </c:pt>
                <c:pt idx="84">
                  <c:v>42.500000000000007</c:v>
                </c:pt>
                <c:pt idx="85">
                  <c:v>42.857142857142861</c:v>
                </c:pt>
                <c:pt idx="86">
                  <c:v>84.21052631578948</c:v>
                </c:pt>
                <c:pt idx="87">
                  <c:v>100</c:v>
                </c:pt>
                <c:pt idx="88">
                  <c:v>4.1666666666666572</c:v>
                </c:pt>
                <c:pt idx="89">
                  <c:v>24</c:v>
                </c:pt>
                <c:pt idx="90">
                  <c:v>23.181818181818187</c:v>
                </c:pt>
                <c:pt idx="91">
                  <c:v>11</c:v>
                </c:pt>
                <c:pt idx="92">
                  <c:v>28.333333333333329</c:v>
                </c:pt>
                <c:pt idx="93">
                  <c:v>19.130434782608702</c:v>
                </c:pt>
                <c:pt idx="94">
                  <c:v>19.090909090909093</c:v>
                </c:pt>
                <c:pt idx="95">
                  <c:v>61.403508771929829</c:v>
                </c:pt>
                <c:pt idx="96">
                  <c:v>17.5</c:v>
                </c:pt>
                <c:pt idx="97">
                  <c:v>25</c:v>
                </c:pt>
                <c:pt idx="98">
                  <c:v>65.116279069767444</c:v>
                </c:pt>
                <c:pt idx="99">
                  <c:v>76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2A59-477F-BD54-EE1B13749B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937521072"/>
        <c:axId val="1937524400"/>
      </c:barChart>
      <c:catAx>
        <c:axId val="19375210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solates</a:t>
                </a:r>
                <a:endParaRPr lang="ko-KR" altLang="en-US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1937524400"/>
        <c:crosses val="autoZero"/>
        <c:auto val="1"/>
        <c:lblAlgn val="ctr"/>
        <c:lblOffset val="100"/>
        <c:noMultiLvlLbl val="0"/>
      </c:catAx>
      <c:valAx>
        <c:axId val="1937524400"/>
        <c:scaling>
          <c:orientation val="minMax"/>
          <c:max val="100"/>
          <c:min val="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ko-KR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 Mortality of </a:t>
                </a:r>
                <a:r>
                  <a:rPr lang="en-US" altLang="ko-KR" i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phis</a:t>
                </a:r>
                <a:r>
                  <a:rPr lang="en-US" altLang="ko-KR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ko-KR" i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ossypii</a:t>
                </a:r>
                <a:r>
                  <a:rPr lang="en-US" altLang="ko-KR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nymphs</a:t>
                </a:r>
                <a:endParaRPr lang="ko-KR" altLang="en-US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193752107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B66B2-6BF8-49D7-987E-E99DECC6D214}" type="datetimeFigureOut">
              <a:rPr lang="ko-KR" altLang="en-US" smtClean="0"/>
              <a:t>2022-03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72B45-EE92-4DB0-BA2D-07C00ABA77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74780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B66B2-6BF8-49D7-987E-E99DECC6D214}" type="datetimeFigureOut">
              <a:rPr lang="ko-KR" altLang="en-US" smtClean="0"/>
              <a:t>2022-03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72B45-EE92-4DB0-BA2D-07C00ABA77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36256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B66B2-6BF8-49D7-987E-E99DECC6D214}" type="datetimeFigureOut">
              <a:rPr lang="ko-KR" altLang="en-US" smtClean="0"/>
              <a:t>2022-03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72B45-EE92-4DB0-BA2D-07C00ABA77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94002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B66B2-6BF8-49D7-987E-E99DECC6D214}" type="datetimeFigureOut">
              <a:rPr lang="ko-KR" altLang="en-US" smtClean="0"/>
              <a:t>2022-03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72B45-EE92-4DB0-BA2D-07C00ABA77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39787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B66B2-6BF8-49D7-987E-E99DECC6D214}" type="datetimeFigureOut">
              <a:rPr lang="ko-KR" altLang="en-US" smtClean="0"/>
              <a:t>2022-03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72B45-EE92-4DB0-BA2D-07C00ABA77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9077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B66B2-6BF8-49D7-987E-E99DECC6D214}" type="datetimeFigureOut">
              <a:rPr lang="ko-KR" altLang="en-US" smtClean="0"/>
              <a:t>2022-03-2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72B45-EE92-4DB0-BA2D-07C00ABA77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3163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B66B2-6BF8-49D7-987E-E99DECC6D214}" type="datetimeFigureOut">
              <a:rPr lang="ko-KR" altLang="en-US" smtClean="0"/>
              <a:t>2022-03-2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72B45-EE92-4DB0-BA2D-07C00ABA77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28065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B66B2-6BF8-49D7-987E-E99DECC6D214}" type="datetimeFigureOut">
              <a:rPr lang="ko-KR" altLang="en-US" smtClean="0"/>
              <a:t>2022-03-2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72B45-EE92-4DB0-BA2D-07C00ABA77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6025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B66B2-6BF8-49D7-987E-E99DECC6D214}" type="datetimeFigureOut">
              <a:rPr lang="ko-KR" altLang="en-US" smtClean="0"/>
              <a:t>2022-03-2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72B45-EE92-4DB0-BA2D-07C00ABA77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2286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B66B2-6BF8-49D7-987E-E99DECC6D214}" type="datetimeFigureOut">
              <a:rPr lang="ko-KR" altLang="en-US" smtClean="0"/>
              <a:t>2022-03-2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72B45-EE92-4DB0-BA2D-07C00ABA77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3621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B66B2-6BF8-49D7-987E-E99DECC6D214}" type="datetimeFigureOut">
              <a:rPr lang="ko-KR" altLang="en-US" smtClean="0"/>
              <a:t>2022-03-2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72B45-EE92-4DB0-BA2D-07C00ABA77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360855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8B66B2-6BF8-49D7-987E-E99DECC6D214}" type="datetimeFigureOut">
              <a:rPr lang="ko-KR" altLang="en-US" smtClean="0"/>
              <a:t>2022-03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672B45-EE92-4DB0-BA2D-07C00ABA77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05748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차트 6">
            <a:extLst>
              <a:ext uri="{FF2B5EF4-FFF2-40B4-BE49-F238E27FC236}">
                <a16:creationId xmlns:a16="http://schemas.microsoft.com/office/drawing/2014/main" id="{1CC9C209-0EA1-4F9E-A80F-31A94037338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3117090"/>
              </p:ext>
            </p:extLst>
          </p:nvPr>
        </p:nvGraphicFramePr>
        <p:xfrm>
          <a:off x="811481" y="485683"/>
          <a:ext cx="5235038" cy="93053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4AAF399D-A7EE-43CC-8907-B552D3684568}"/>
              </a:ext>
            </a:extLst>
          </p:cNvPr>
          <p:cNvSpPr txBox="1"/>
          <p:nvPr/>
        </p:nvSpPr>
        <p:spPr>
          <a:xfrm>
            <a:off x="453077" y="198787"/>
            <a:ext cx="1135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ko-KR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00605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065</TotalTime>
  <Words>9</Words>
  <Application>Microsoft Office PowerPoint</Application>
  <PresentationFormat>A4 용지(210x297mm)</PresentationFormat>
  <Paragraphs>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im yeram</dc:creator>
  <cp:lastModifiedBy>김재수</cp:lastModifiedBy>
  <cp:revision>76</cp:revision>
  <dcterms:created xsi:type="dcterms:W3CDTF">2022-01-18T04:17:33Z</dcterms:created>
  <dcterms:modified xsi:type="dcterms:W3CDTF">2022-03-29T05:26:11Z</dcterms:modified>
</cp:coreProperties>
</file>